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ngesInfos/changesInfo1.xml" ContentType="application/vnd.ms-powerpoint.changesinfo+xml"/>
  <Override PartName="/ppt/revisionInfo.xml" ContentType="application/vnd.ms-powerpoint.revisioninfo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4"/>
  </p:sldMasterIdLst>
  <p:notesMasterIdLst>
    <p:notesMasterId r:id="rId6"/>
  </p:notesMasterIdLst>
  <p:sldIdLst>
    <p:sldId id="361" r:id="rId5"/>
  </p:sldIdLst>
  <p:sldSz cx="7772400" cy="100584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B1991432-16D4-A338-8C74-AA5AE8E7A6BA}" name="BeKa Leuschen-Kohl" initials="BLK" userId="BeKa Leuschen-Kohl" providerId="None"/>
  <p188:author id="{152ED23C-9289-3640-DC9D-A0185063BC84}" name="Iyer-Pascuzzi, Anjali" initials="IA" userId="S::aiyerpas@purdue.edu::dcf03dc3-b88b-4fb8-8f79-4d9cab98b2b3" providerId="AD"/>
  <p188:author id="{22EA6AEE-A713-B989-205E-2187CD1F1D1A}" name="Rebecca Lynn Leuschen-kohl" initials="RL" userId="S::rleusche@purdue.edu::00225fb4-0928-44a2-820d-794618e88de9" providerId="AD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BDBDBD"/>
    <a:srgbClr val="949F95"/>
    <a:srgbClr val="DEDEDE"/>
    <a:srgbClr val="ADB9CA"/>
    <a:srgbClr val="FFFFFF"/>
    <a:srgbClr val="4F4390"/>
    <a:srgbClr val="FFBDDE"/>
    <a:srgbClr val="B3B3B3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B73B4C1A-DA0E-482D-A7AD-C4D8E4204240}" v="10" dt="2024-11-05T00:45:38.836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69012ECD-51FC-41F1-AA8D-1B2483CD663E}" styleName="Light Style 2 - Accent 1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</a:tcBdr>
      </a:tcStyle>
    </a:band1H>
    <a:band1V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</a:tcBdr>
      </a:tcStyle>
    </a:band1V>
    <a:band2V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1"/>
        </a:fillRef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72" d="100"/>
          <a:sy n="72" d="100"/>
        </p:scale>
        <p:origin x="2979" y="3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13" Type="http://schemas.microsoft.com/office/2018/10/relationships/authors" Target="authors.xml"/><Relationship Id="rId3" Type="http://schemas.openxmlformats.org/officeDocument/2006/relationships/customXml" Target="../customXml/item3.xml"/><Relationship Id="rId7" Type="http://schemas.openxmlformats.org/officeDocument/2006/relationships/presProps" Target="presProps.xml"/><Relationship Id="rId12" Type="http://schemas.microsoft.com/office/2015/10/relationships/revisionInfo" Target="revisionInfo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notesMaster" Target="notesMasters/notesMaster1.xml"/><Relationship Id="rId11" Type="http://schemas.microsoft.com/office/2016/11/relationships/changesInfo" Target="changesInfos/changesInfo1.xml"/><Relationship Id="rId5" Type="http://schemas.openxmlformats.org/officeDocument/2006/relationships/slide" Target="slides/slide1.xml"/><Relationship Id="rId10" Type="http://schemas.openxmlformats.org/officeDocument/2006/relationships/tableStyles" Target="tableStyles.xml"/><Relationship Id="rId4" Type="http://schemas.openxmlformats.org/officeDocument/2006/relationships/slideMaster" Target="slideMasters/slideMaster1.xml"/><Relationship Id="rId9" Type="http://schemas.openxmlformats.org/officeDocument/2006/relationships/theme" Target="theme/theme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Rebecca Leuschen-Kohl" userId="ef62846a7a2008e6" providerId="LiveId" clId="{B73B4C1A-DA0E-482D-A7AD-C4D8E4204240}"/>
    <pc:docChg chg="undo custSel delSld modSld">
      <pc:chgData name="Rebecca Leuschen-Kohl" userId="ef62846a7a2008e6" providerId="LiveId" clId="{B73B4C1A-DA0E-482D-A7AD-C4D8E4204240}" dt="2024-11-05T00:55:45.361" v="40" actId="1076"/>
      <pc:docMkLst>
        <pc:docMk/>
      </pc:docMkLst>
      <pc:sldChg chg="del">
        <pc:chgData name="Rebecca Leuschen-Kohl" userId="ef62846a7a2008e6" providerId="LiveId" clId="{B73B4C1A-DA0E-482D-A7AD-C4D8E4204240}" dt="2024-11-05T00:47:20.832" v="39" actId="47"/>
        <pc:sldMkLst>
          <pc:docMk/>
          <pc:sldMk cId="830658197" sldId="332"/>
        </pc:sldMkLst>
      </pc:sldChg>
      <pc:sldChg chg="del">
        <pc:chgData name="Rebecca Leuschen-Kohl" userId="ef62846a7a2008e6" providerId="LiveId" clId="{B73B4C1A-DA0E-482D-A7AD-C4D8E4204240}" dt="2024-11-05T00:40:47.806" v="0" actId="47"/>
        <pc:sldMkLst>
          <pc:docMk/>
          <pc:sldMk cId="3398032437" sldId="336"/>
        </pc:sldMkLst>
      </pc:sldChg>
      <pc:sldChg chg="del">
        <pc:chgData name="Rebecca Leuschen-Kohl" userId="ef62846a7a2008e6" providerId="LiveId" clId="{B73B4C1A-DA0E-482D-A7AD-C4D8E4204240}" dt="2024-11-05T00:40:47.806" v="0" actId="47"/>
        <pc:sldMkLst>
          <pc:docMk/>
          <pc:sldMk cId="3793326182" sldId="338"/>
        </pc:sldMkLst>
      </pc:sldChg>
      <pc:sldChg chg="del">
        <pc:chgData name="Rebecca Leuschen-Kohl" userId="ef62846a7a2008e6" providerId="LiveId" clId="{B73B4C1A-DA0E-482D-A7AD-C4D8E4204240}" dt="2024-11-05T00:47:20.832" v="39" actId="47"/>
        <pc:sldMkLst>
          <pc:docMk/>
          <pc:sldMk cId="1961722243" sldId="339"/>
        </pc:sldMkLst>
      </pc:sldChg>
      <pc:sldChg chg="del">
        <pc:chgData name="Rebecca Leuschen-Kohl" userId="ef62846a7a2008e6" providerId="LiveId" clId="{B73B4C1A-DA0E-482D-A7AD-C4D8E4204240}" dt="2024-11-05T00:40:49.651" v="1" actId="47"/>
        <pc:sldMkLst>
          <pc:docMk/>
          <pc:sldMk cId="2349073536" sldId="347"/>
        </pc:sldMkLst>
      </pc:sldChg>
      <pc:sldChg chg="del">
        <pc:chgData name="Rebecca Leuschen-Kohl" userId="ef62846a7a2008e6" providerId="LiveId" clId="{B73B4C1A-DA0E-482D-A7AD-C4D8E4204240}" dt="2024-11-05T00:47:20.832" v="39" actId="47"/>
        <pc:sldMkLst>
          <pc:docMk/>
          <pc:sldMk cId="830734933" sldId="348"/>
        </pc:sldMkLst>
      </pc:sldChg>
      <pc:sldChg chg="del">
        <pc:chgData name="Rebecca Leuschen-Kohl" userId="ef62846a7a2008e6" providerId="LiveId" clId="{B73B4C1A-DA0E-482D-A7AD-C4D8E4204240}" dt="2024-11-05T00:40:50.358" v="2" actId="47"/>
        <pc:sldMkLst>
          <pc:docMk/>
          <pc:sldMk cId="397969387" sldId="349"/>
        </pc:sldMkLst>
      </pc:sldChg>
      <pc:sldChg chg="del">
        <pc:chgData name="Rebecca Leuschen-Kohl" userId="ef62846a7a2008e6" providerId="LiveId" clId="{B73B4C1A-DA0E-482D-A7AD-C4D8E4204240}" dt="2024-11-05T00:40:53.110" v="4" actId="47"/>
        <pc:sldMkLst>
          <pc:docMk/>
          <pc:sldMk cId="1704172087" sldId="351"/>
        </pc:sldMkLst>
      </pc:sldChg>
      <pc:sldChg chg="del">
        <pc:chgData name="Rebecca Leuschen-Kohl" userId="ef62846a7a2008e6" providerId="LiveId" clId="{B73B4C1A-DA0E-482D-A7AD-C4D8E4204240}" dt="2024-11-05T00:40:50.976" v="3" actId="47"/>
        <pc:sldMkLst>
          <pc:docMk/>
          <pc:sldMk cId="3486478879" sldId="353"/>
        </pc:sldMkLst>
      </pc:sldChg>
      <pc:sldChg chg="del">
        <pc:chgData name="Rebecca Leuschen-Kohl" userId="ef62846a7a2008e6" providerId="LiveId" clId="{B73B4C1A-DA0E-482D-A7AD-C4D8E4204240}" dt="2024-11-05T00:47:20.832" v="39" actId="47"/>
        <pc:sldMkLst>
          <pc:docMk/>
          <pc:sldMk cId="2478473178" sldId="354"/>
        </pc:sldMkLst>
      </pc:sldChg>
      <pc:sldChg chg="del">
        <pc:chgData name="Rebecca Leuschen-Kohl" userId="ef62846a7a2008e6" providerId="LiveId" clId="{B73B4C1A-DA0E-482D-A7AD-C4D8E4204240}" dt="2024-11-05T00:47:20.832" v="39" actId="47"/>
        <pc:sldMkLst>
          <pc:docMk/>
          <pc:sldMk cId="2416863298" sldId="355"/>
        </pc:sldMkLst>
      </pc:sldChg>
      <pc:sldChg chg="del">
        <pc:chgData name="Rebecca Leuschen-Kohl" userId="ef62846a7a2008e6" providerId="LiveId" clId="{B73B4C1A-DA0E-482D-A7AD-C4D8E4204240}" dt="2024-11-05T00:40:54.280" v="5" actId="47"/>
        <pc:sldMkLst>
          <pc:docMk/>
          <pc:sldMk cId="568157699" sldId="356"/>
        </pc:sldMkLst>
      </pc:sldChg>
      <pc:sldChg chg="del">
        <pc:chgData name="Rebecca Leuschen-Kohl" userId="ef62846a7a2008e6" providerId="LiveId" clId="{B73B4C1A-DA0E-482D-A7AD-C4D8E4204240}" dt="2024-11-05T00:47:20.832" v="39" actId="47"/>
        <pc:sldMkLst>
          <pc:docMk/>
          <pc:sldMk cId="1185421222" sldId="359"/>
        </pc:sldMkLst>
      </pc:sldChg>
      <pc:sldChg chg="addSp delSp modSp mod">
        <pc:chgData name="Rebecca Leuschen-Kohl" userId="ef62846a7a2008e6" providerId="LiveId" clId="{B73B4C1A-DA0E-482D-A7AD-C4D8E4204240}" dt="2024-11-05T00:55:45.361" v="40" actId="1076"/>
        <pc:sldMkLst>
          <pc:docMk/>
          <pc:sldMk cId="83140915" sldId="361"/>
        </pc:sldMkLst>
        <pc:spChg chg="mod">
          <ac:chgData name="Rebecca Leuschen-Kohl" userId="ef62846a7a2008e6" providerId="LiveId" clId="{B73B4C1A-DA0E-482D-A7AD-C4D8E4204240}" dt="2024-11-05T00:55:45.361" v="40" actId="1076"/>
          <ac:spMkLst>
            <pc:docMk/>
            <pc:sldMk cId="83140915" sldId="361"/>
            <ac:spMk id="6" creationId="{02351F83-4862-434E-0F27-50524128DA46}"/>
          </ac:spMkLst>
        </pc:spChg>
        <pc:graphicFrameChg chg="add del mod">
          <ac:chgData name="Rebecca Leuschen-Kohl" userId="ef62846a7a2008e6" providerId="LiveId" clId="{B73B4C1A-DA0E-482D-A7AD-C4D8E4204240}" dt="2024-11-05T00:46:23.941" v="30" actId="478"/>
          <ac:graphicFrameMkLst>
            <pc:docMk/>
            <pc:sldMk cId="83140915" sldId="361"/>
            <ac:graphicFrameMk id="2" creationId="{E6496AB7-2C3C-4A6C-8E45-701EDBEE3DF7}"/>
          </ac:graphicFrameMkLst>
        </pc:graphicFrameChg>
        <pc:graphicFrameChg chg="add del">
          <ac:chgData name="Rebecca Leuschen-Kohl" userId="ef62846a7a2008e6" providerId="LiveId" clId="{B73B4C1A-DA0E-482D-A7AD-C4D8E4204240}" dt="2024-11-05T00:44:03.801" v="27" actId="478"/>
          <ac:graphicFrameMkLst>
            <pc:docMk/>
            <pc:sldMk cId="83140915" sldId="361"/>
            <ac:graphicFrameMk id="9" creationId="{E6496AB7-2C3C-4A6C-8E45-701EDBEE3DF7}"/>
          </ac:graphicFrameMkLst>
        </pc:graphicFrameChg>
        <pc:picChg chg="add del mod">
          <ac:chgData name="Rebecca Leuschen-Kohl" userId="ef62846a7a2008e6" providerId="LiveId" clId="{B73B4C1A-DA0E-482D-A7AD-C4D8E4204240}" dt="2024-11-05T00:46:39.262" v="35" actId="478"/>
          <ac:picMkLst>
            <pc:docMk/>
            <pc:sldMk cId="83140915" sldId="361"/>
            <ac:picMk id="4" creationId="{77F6EB8D-A8EC-A29B-5F8D-3CA34F35A90A}"/>
          </ac:picMkLst>
        </pc:picChg>
        <pc:picChg chg="add mod">
          <ac:chgData name="Rebecca Leuschen-Kohl" userId="ef62846a7a2008e6" providerId="LiveId" clId="{B73B4C1A-DA0E-482D-A7AD-C4D8E4204240}" dt="2024-11-05T00:47:17.708" v="38" actId="1076"/>
          <ac:picMkLst>
            <pc:docMk/>
            <pc:sldMk cId="83140915" sldId="361"/>
            <ac:picMk id="7" creationId="{E1E0ADC5-5AB5-EA82-0B9B-D60F43CCCB4B}"/>
          </ac:picMkLst>
        </pc:picChg>
      </pc:sldChg>
      <pc:sldChg chg="del">
        <pc:chgData name="Rebecca Leuschen-Kohl" userId="ef62846a7a2008e6" providerId="LiveId" clId="{B73B4C1A-DA0E-482D-A7AD-C4D8E4204240}" dt="2024-11-05T00:40:47.806" v="0" actId="47"/>
        <pc:sldMkLst>
          <pc:docMk/>
          <pc:sldMk cId="58006295" sldId="363"/>
        </pc:sldMkLst>
      </pc:sldChg>
      <pc:sldChg chg="del">
        <pc:chgData name="Rebecca Leuschen-Kohl" userId="ef62846a7a2008e6" providerId="LiveId" clId="{B73B4C1A-DA0E-482D-A7AD-C4D8E4204240}" dt="2024-11-05T00:40:47.806" v="0" actId="47"/>
        <pc:sldMkLst>
          <pc:docMk/>
          <pc:sldMk cId="4206593612" sldId="364"/>
        </pc:sldMkLst>
      </pc:sldChg>
      <pc:sldChg chg="del">
        <pc:chgData name="Rebecca Leuschen-Kohl" userId="ef62846a7a2008e6" providerId="LiveId" clId="{B73B4C1A-DA0E-482D-A7AD-C4D8E4204240}" dt="2024-11-05T00:47:20.832" v="39" actId="47"/>
        <pc:sldMkLst>
          <pc:docMk/>
          <pc:sldMk cId="2301688996" sldId="365"/>
        </pc:sldMkLst>
      </pc:sldChg>
      <pc:sldChg chg="del">
        <pc:chgData name="Rebecca Leuschen-Kohl" userId="ef62846a7a2008e6" providerId="LiveId" clId="{B73B4C1A-DA0E-482D-A7AD-C4D8E4204240}" dt="2024-11-05T00:47:20.832" v="39" actId="47"/>
        <pc:sldMkLst>
          <pc:docMk/>
          <pc:sldMk cId="471017098" sldId="366"/>
        </pc:sldMkLst>
      </pc:sldChg>
      <pc:sldChg chg="del">
        <pc:chgData name="Rebecca Leuschen-Kohl" userId="ef62846a7a2008e6" providerId="LiveId" clId="{B73B4C1A-DA0E-482D-A7AD-C4D8E4204240}" dt="2024-11-05T00:47:20.832" v="39" actId="47"/>
        <pc:sldMkLst>
          <pc:docMk/>
          <pc:sldMk cId="1752517358" sldId="367"/>
        </pc:sldMkLst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25C9A0A-66B1-4FAF-A1C5-2E9142573E35}" type="datetimeFigureOut">
              <a:rPr lang="en-US" smtClean="0"/>
              <a:t>11/4/20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36788" y="1143000"/>
            <a:ext cx="23844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CC2AFF7-3C64-424C-82FD-976B3E97E4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076585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CC2AFF7-3C64-424C-82FD-976B3E97E48E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2746056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82930" y="1646133"/>
            <a:ext cx="6606540" cy="3501813"/>
          </a:xfrm>
        </p:spPr>
        <p:txBody>
          <a:bodyPr anchor="b"/>
          <a:lstStyle>
            <a:lvl1pPr algn="ctr">
              <a:defRPr sz="51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71550" y="5282989"/>
            <a:ext cx="5829300" cy="2428451"/>
          </a:xfrm>
        </p:spPr>
        <p:txBody>
          <a:bodyPr/>
          <a:lstStyle>
            <a:lvl1pPr marL="0" indent="0" algn="ctr">
              <a:buNone/>
              <a:defRPr sz="2040"/>
            </a:lvl1pPr>
            <a:lvl2pPr marL="388620" indent="0" algn="ctr">
              <a:buNone/>
              <a:defRPr sz="1700"/>
            </a:lvl2pPr>
            <a:lvl3pPr marL="777240" indent="0" algn="ctr">
              <a:buNone/>
              <a:defRPr sz="1530"/>
            </a:lvl3pPr>
            <a:lvl4pPr marL="1165860" indent="0" algn="ctr">
              <a:buNone/>
              <a:defRPr sz="1360"/>
            </a:lvl4pPr>
            <a:lvl5pPr marL="1554480" indent="0" algn="ctr">
              <a:buNone/>
              <a:defRPr sz="1360"/>
            </a:lvl5pPr>
            <a:lvl6pPr marL="1943100" indent="0" algn="ctr">
              <a:buNone/>
              <a:defRPr sz="1360"/>
            </a:lvl6pPr>
            <a:lvl7pPr marL="2331720" indent="0" algn="ctr">
              <a:buNone/>
              <a:defRPr sz="1360"/>
            </a:lvl7pPr>
            <a:lvl8pPr marL="2720340" indent="0" algn="ctr">
              <a:buNone/>
              <a:defRPr sz="1360"/>
            </a:lvl8pPr>
            <a:lvl9pPr marL="3108960" indent="0" algn="ctr">
              <a:buNone/>
              <a:defRPr sz="136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661ED3-D41B-4A2F-90AC-239322BE671F}" type="datetimeFigureOut">
              <a:rPr lang="en-US" smtClean="0"/>
              <a:t>11/4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AA9427-4F86-44AA-9A4C-1D4AB0B01C9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236908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661ED3-D41B-4A2F-90AC-239322BE671F}" type="datetimeFigureOut">
              <a:rPr lang="en-US" smtClean="0"/>
              <a:t>11/4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AA9427-4F86-44AA-9A4C-1D4AB0B01C9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2704868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562124" y="535517"/>
            <a:ext cx="1675924" cy="8524029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34353" y="535517"/>
            <a:ext cx="4930616" cy="8524029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661ED3-D41B-4A2F-90AC-239322BE671F}" type="datetimeFigureOut">
              <a:rPr lang="en-US" smtClean="0"/>
              <a:t>11/4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AA9427-4F86-44AA-9A4C-1D4AB0B01C9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906677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661ED3-D41B-4A2F-90AC-239322BE671F}" type="datetimeFigureOut">
              <a:rPr lang="en-US" smtClean="0"/>
              <a:t>11/4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AA9427-4F86-44AA-9A4C-1D4AB0B01C9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5674052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0305" y="2507618"/>
            <a:ext cx="6703695" cy="4184014"/>
          </a:xfrm>
        </p:spPr>
        <p:txBody>
          <a:bodyPr anchor="b"/>
          <a:lstStyle>
            <a:lvl1pPr>
              <a:defRPr sz="51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0305" y="6731215"/>
            <a:ext cx="6703695" cy="2200274"/>
          </a:xfrm>
        </p:spPr>
        <p:txBody>
          <a:bodyPr/>
          <a:lstStyle>
            <a:lvl1pPr marL="0" indent="0">
              <a:buNone/>
              <a:defRPr sz="2040">
                <a:solidFill>
                  <a:schemeClr val="tx1"/>
                </a:solidFill>
              </a:defRPr>
            </a:lvl1pPr>
            <a:lvl2pPr marL="388620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2pPr>
            <a:lvl3pPr marL="777240" indent="0">
              <a:buNone/>
              <a:defRPr sz="1530">
                <a:solidFill>
                  <a:schemeClr val="tx1">
                    <a:tint val="75000"/>
                  </a:schemeClr>
                </a:solidFill>
              </a:defRPr>
            </a:lvl3pPr>
            <a:lvl4pPr marL="11658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4pPr>
            <a:lvl5pPr marL="155448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5pPr>
            <a:lvl6pPr marL="194310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6pPr>
            <a:lvl7pPr marL="233172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7pPr>
            <a:lvl8pPr marL="272034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8pPr>
            <a:lvl9pPr marL="31089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661ED3-D41B-4A2F-90AC-239322BE671F}" type="datetimeFigureOut">
              <a:rPr lang="en-US" smtClean="0"/>
              <a:t>11/4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AA9427-4F86-44AA-9A4C-1D4AB0B01C9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088638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34353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934778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661ED3-D41B-4A2F-90AC-239322BE671F}" type="datetimeFigureOut">
              <a:rPr lang="en-US" smtClean="0"/>
              <a:t>11/4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AA9427-4F86-44AA-9A4C-1D4AB0B01C9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799521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535519"/>
            <a:ext cx="6703695" cy="1944159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5366" y="2465706"/>
            <a:ext cx="3288089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35366" y="3674110"/>
            <a:ext cx="3288089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934778" y="2465706"/>
            <a:ext cx="3304282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934778" y="3674110"/>
            <a:ext cx="3304282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661ED3-D41B-4A2F-90AC-239322BE671F}" type="datetimeFigureOut">
              <a:rPr lang="en-US" smtClean="0"/>
              <a:t>11/4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AA9427-4F86-44AA-9A4C-1D4AB0B01C9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206587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661ED3-D41B-4A2F-90AC-239322BE671F}" type="datetimeFigureOut">
              <a:rPr lang="en-US" smtClean="0"/>
              <a:t>11/4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AA9427-4F86-44AA-9A4C-1D4AB0B01C9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8903555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661ED3-D41B-4A2F-90AC-239322BE671F}" type="datetimeFigureOut">
              <a:rPr lang="en-US" smtClean="0"/>
              <a:t>11/4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AA9427-4F86-44AA-9A4C-1D4AB0B01C9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2840835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304282" y="1448226"/>
            <a:ext cx="3934778" cy="7147983"/>
          </a:xfrm>
        </p:spPr>
        <p:txBody>
          <a:bodyPr/>
          <a:lstStyle>
            <a:lvl1pPr>
              <a:defRPr sz="2720"/>
            </a:lvl1pPr>
            <a:lvl2pPr>
              <a:defRPr sz="2380"/>
            </a:lvl2pPr>
            <a:lvl3pPr>
              <a:defRPr sz="2040"/>
            </a:lvl3pPr>
            <a:lvl4pPr>
              <a:defRPr sz="1700"/>
            </a:lvl4pPr>
            <a:lvl5pPr>
              <a:defRPr sz="1700"/>
            </a:lvl5pPr>
            <a:lvl6pPr>
              <a:defRPr sz="1700"/>
            </a:lvl6pPr>
            <a:lvl7pPr>
              <a:defRPr sz="1700"/>
            </a:lvl7pPr>
            <a:lvl8pPr>
              <a:defRPr sz="1700"/>
            </a:lvl8pPr>
            <a:lvl9pPr>
              <a:defRPr sz="17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661ED3-D41B-4A2F-90AC-239322BE671F}" type="datetimeFigureOut">
              <a:rPr lang="en-US" smtClean="0"/>
              <a:t>11/4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AA9427-4F86-44AA-9A4C-1D4AB0B01C9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0066134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304282" y="1448226"/>
            <a:ext cx="3934778" cy="7147983"/>
          </a:xfrm>
        </p:spPr>
        <p:txBody>
          <a:bodyPr anchor="t"/>
          <a:lstStyle>
            <a:lvl1pPr marL="0" indent="0">
              <a:buNone/>
              <a:defRPr sz="2720"/>
            </a:lvl1pPr>
            <a:lvl2pPr marL="388620" indent="0">
              <a:buNone/>
              <a:defRPr sz="2380"/>
            </a:lvl2pPr>
            <a:lvl3pPr marL="777240" indent="0">
              <a:buNone/>
              <a:defRPr sz="2040"/>
            </a:lvl3pPr>
            <a:lvl4pPr marL="1165860" indent="0">
              <a:buNone/>
              <a:defRPr sz="1700"/>
            </a:lvl4pPr>
            <a:lvl5pPr marL="1554480" indent="0">
              <a:buNone/>
              <a:defRPr sz="1700"/>
            </a:lvl5pPr>
            <a:lvl6pPr marL="1943100" indent="0">
              <a:buNone/>
              <a:defRPr sz="1700"/>
            </a:lvl6pPr>
            <a:lvl7pPr marL="2331720" indent="0">
              <a:buNone/>
              <a:defRPr sz="1700"/>
            </a:lvl7pPr>
            <a:lvl8pPr marL="2720340" indent="0">
              <a:buNone/>
              <a:defRPr sz="1700"/>
            </a:lvl8pPr>
            <a:lvl9pPr marL="3108960" indent="0">
              <a:buNone/>
              <a:defRPr sz="1700"/>
            </a:lvl9pPr>
          </a:lstStyle>
          <a:p>
            <a:r>
              <a:rPr lang="en-US"/>
              <a:t>Click icon to add picture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661ED3-D41B-4A2F-90AC-239322BE671F}" type="datetimeFigureOut">
              <a:rPr lang="en-US" smtClean="0"/>
              <a:t>11/4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AA9427-4F86-44AA-9A4C-1D4AB0B01C9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3062048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34353" y="535519"/>
            <a:ext cx="6703695" cy="194415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4353" y="2677584"/>
            <a:ext cx="6703695" cy="638196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34353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4661ED3-D41B-4A2F-90AC-239322BE671F}" type="datetimeFigureOut">
              <a:rPr lang="en-US" smtClean="0"/>
              <a:t>11/4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74608" y="9322649"/>
            <a:ext cx="2623185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489258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4AA9427-4F86-44AA-9A4C-1D4AB0B01C9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2188333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777240" rtl="0" eaLnBrk="1" latinLnBrk="0" hangingPunct="1">
        <a:lnSpc>
          <a:spcPct val="90000"/>
        </a:lnSpc>
        <a:spcBef>
          <a:spcPct val="0"/>
        </a:spcBef>
        <a:buNone/>
        <a:defRPr sz="374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94310" indent="-194310" algn="l" defTabSz="777240" rtl="0" eaLnBrk="1" latinLnBrk="0" hangingPunct="1">
        <a:lnSpc>
          <a:spcPct val="90000"/>
        </a:lnSpc>
        <a:spcBef>
          <a:spcPts val="850"/>
        </a:spcBef>
        <a:buFont typeface="Arial" panose="020B0604020202020204" pitchFamily="34" charset="0"/>
        <a:buChar char="•"/>
        <a:defRPr sz="2380" kern="1200">
          <a:solidFill>
            <a:schemeClr val="tx1"/>
          </a:solidFill>
          <a:latin typeface="+mn-lt"/>
          <a:ea typeface="+mn-ea"/>
          <a:cs typeface="+mn-cs"/>
        </a:defRPr>
      </a:lvl1pPr>
      <a:lvl2pPr marL="5829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2040" kern="1200">
          <a:solidFill>
            <a:schemeClr val="tx1"/>
          </a:solidFill>
          <a:latin typeface="+mn-lt"/>
          <a:ea typeface="+mn-ea"/>
          <a:cs typeface="+mn-cs"/>
        </a:defRPr>
      </a:lvl2pPr>
      <a:lvl3pPr marL="9715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3pPr>
      <a:lvl4pPr marL="13601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74879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213741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5260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9146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3032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1pPr>
      <a:lvl2pPr marL="3886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2pPr>
      <a:lvl3pPr marL="7772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3pPr>
      <a:lvl4pPr marL="11658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55448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194310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3317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7203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1089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02351F83-4862-434E-0F27-50524128DA46}"/>
              </a:ext>
            </a:extLst>
          </p:cNvPr>
          <p:cNvSpPr txBox="1"/>
          <p:nvPr/>
        </p:nvSpPr>
        <p:spPr>
          <a:xfrm>
            <a:off x="1138329" y="692529"/>
            <a:ext cx="5614679" cy="101566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defTabSz="274012"/>
            <a:r>
              <a:rPr lang="en-US" sz="10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. S4. qPCR of virus-induced gene silencing (VIGS) constructs confirming reduced expression. </a:t>
            </a:r>
            <a:r>
              <a:rPr lang="en-US" sz="1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hown is the fold change relative to the expression of the associated gene in the empty control (EC1) VIGS.</a:t>
            </a:r>
            <a:r>
              <a:rPr lang="en-US" sz="10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 </a:t>
            </a:r>
            <a:r>
              <a:rPr lang="en-US" sz="1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our technical replicates (n=4) and two biological replicates were performed for each VIGS-silenced construct and confirmed for four of the ten VIGS biological replicates with similar results. The standard deviation (n=4) is represented with error bars. The figure below is shows a single VIGS replicate and corresponds with the data shown in Figure S3.  </a:t>
            </a:r>
            <a:endParaRPr lang="en-US" sz="1000" b="1" dirty="0"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E1E0ADC5-5AB5-EA82-0B9B-D60F43CCCB4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533999" y="3042604"/>
            <a:ext cx="4336772" cy="385536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8314091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2013 - 2022 Theme">
  <a:themeElements>
    <a:clrScheme name="Office 2013 - 2022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2013 - 2022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2013 - 2022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2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E56102D0D35E964BBFE2C79D04696EE4" ma:contentTypeVersion="18" ma:contentTypeDescription="Create a new document." ma:contentTypeScope="" ma:versionID="71fc2afbc31600472ab73e35b249ead8">
  <xsd:schema xmlns:xsd="http://www.w3.org/2001/XMLSchema" xmlns:xs="http://www.w3.org/2001/XMLSchema" xmlns:p="http://schemas.microsoft.com/office/2006/metadata/properties" xmlns:ns2="974c5d5a-69c4-47c0-8134-bb286fa4472c" xmlns:ns3="746cde4b-492d-48ba-92d7-9676a22a1012" targetNamespace="http://schemas.microsoft.com/office/2006/metadata/properties" ma:root="true" ma:fieldsID="23e452dd77b66b46fbeaa7a26eb6c6ab" ns2:_="" ns3:_="">
    <xsd:import namespace="974c5d5a-69c4-47c0-8134-bb286fa4472c"/>
    <xsd:import namespace="746cde4b-492d-48ba-92d7-9676a22a1012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2:MediaServiceAutoKeyPoints" minOccurs="0"/>
                <xsd:element ref="ns2:MediaServiceKeyPoints" minOccurs="0"/>
                <xsd:element ref="ns2:MediaServiceAutoTags" minOccurs="0"/>
                <xsd:element ref="ns2:MediaServiceOCR" minOccurs="0"/>
                <xsd:element ref="ns2:MediaServiceGenerationTime" minOccurs="0"/>
                <xsd:element ref="ns2:MediaServiceEventHashCode" minOccurs="0"/>
                <xsd:element ref="ns2:MediaServiceDateTaken" minOccurs="0"/>
                <xsd:element ref="ns2:MediaServiceLocation" minOccurs="0"/>
                <xsd:element ref="ns2:lcf76f155ced4ddcb4097134ff3c332f" minOccurs="0"/>
                <xsd:element ref="ns3:TaxCatchAll" minOccurs="0"/>
                <xsd:element ref="ns2:MediaLengthInSeconds" minOccurs="0"/>
                <xsd:element ref="ns3:SharedWithUsers" minOccurs="0"/>
                <xsd:element ref="ns3:SharedWithDetails" minOccurs="0"/>
                <xsd:element ref="ns2:MediaServiceObjectDetectorVersions" minOccurs="0"/>
                <xsd:element ref="ns2:MediaServiceSearchPropertie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974c5d5a-69c4-47c0-8134-bb286fa4472c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0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1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AutoTags" ma:index="12" nillable="true" ma:displayName="Tags" ma:internalName="MediaServiceAutoTags" ma:readOnly="true">
      <xsd:simpleType>
        <xsd:restriction base="dms:Text"/>
      </xsd:simpleType>
    </xsd:element>
    <xsd:element name="MediaServiceOCR" ma:index="13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4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5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DateTaken" ma:index="16" nillable="true" ma:displayName="MediaServiceDateTaken" ma:hidden="true" ma:internalName="MediaServiceDateTaken" ma:readOnly="true">
      <xsd:simpleType>
        <xsd:restriction base="dms:Text"/>
      </xsd:simpleType>
    </xsd:element>
    <xsd:element name="MediaServiceLocation" ma:index="17" nillable="true" ma:displayName="Location" ma:internalName="MediaServiceLocation" ma:readOnly="true">
      <xsd:simpleType>
        <xsd:restriction base="dms:Text"/>
      </xsd:simpleType>
    </xsd:element>
    <xsd:element name="lcf76f155ced4ddcb4097134ff3c332f" ma:index="19" nillable="true" ma:taxonomy="true" ma:internalName="lcf76f155ced4ddcb4097134ff3c332f" ma:taxonomyFieldName="MediaServiceImageTags" ma:displayName="Image Tags" ma:readOnly="false" ma:fieldId="{5cf76f15-5ced-4ddc-b409-7134ff3c332f}" ma:taxonomyMulti="true" ma:sspId="8e9e90a8-b24c-4be7-8760-a88b2cd47eb1" ma:termSetId="09814cd3-568e-fe90-9814-8d621ff8fb84" ma:anchorId="fba54fb3-c3e1-fe81-a776-ca4b69148c4d" ma:open="true" ma:isKeyword="false">
      <xsd:complexType>
        <xsd:sequence>
          <xsd:element ref="pc:Terms" minOccurs="0" maxOccurs="1"/>
        </xsd:sequence>
      </xsd:complexType>
    </xsd:element>
    <xsd:element name="MediaLengthInSeconds" ma:index="21" nillable="true" ma:displayName="MediaLengthInSeconds" ma:hidden="true" ma:internalName="MediaLengthInSeconds" ma:readOnly="true">
      <xsd:simpleType>
        <xsd:restriction base="dms:Unknown"/>
      </xsd:simpleType>
    </xsd:element>
    <xsd:element name="MediaServiceObjectDetectorVersions" ma:index="24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  <xsd:element name="MediaServiceSearchProperties" ma:index="25" nillable="true" ma:displayName="MediaServiceSearchProperties" ma:hidden="true" ma:internalName="MediaServiceSearchProperties" ma:readOnly="true">
      <xsd:simpleType>
        <xsd:restriction base="dms:Note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746cde4b-492d-48ba-92d7-9676a22a1012" elementFormDefault="qualified">
    <xsd:import namespace="http://schemas.microsoft.com/office/2006/documentManagement/types"/>
    <xsd:import namespace="http://schemas.microsoft.com/office/infopath/2007/PartnerControls"/>
    <xsd:element name="TaxCatchAll" ma:index="20" nillable="true" ma:displayName="Taxonomy Catch All Column" ma:hidden="true" ma:list="{f532aa21-857b-4867-95d0-9dc152152f45}" ma:internalName="TaxCatchAll" ma:showField="CatchAllData" ma:web="746cde4b-492d-48ba-92d7-9676a22a1012">
      <xsd:complexType>
        <xsd:complexContent>
          <xsd:extension base="dms:MultiChoiceLookup">
            <xsd:sequence>
              <xsd:element name="Value" type="dms:Lookup" maxOccurs="unbounded" minOccurs="0" nillable="true"/>
            </xsd:sequence>
          </xsd:extension>
        </xsd:complexContent>
      </xsd:complexType>
    </xsd:element>
    <xsd:element name="SharedWithUsers" ma:index="22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23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lcf76f155ced4ddcb4097134ff3c332f xmlns="974c5d5a-69c4-47c0-8134-bb286fa4472c">
      <Terms xmlns="http://schemas.microsoft.com/office/infopath/2007/PartnerControls"/>
    </lcf76f155ced4ddcb4097134ff3c332f>
    <TaxCatchAll xmlns="746cde4b-492d-48ba-92d7-9676a22a1012" xsi:nil="true"/>
  </documentManagement>
</p:properties>
</file>

<file path=customXml/itemProps1.xml><?xml version="1.0" encoding="utf-8"?>
<ds:datastoreItem xmlns:ds="http://schemas.openxmlformats.org/officeDocument/2006/customXml" ds:itemID="{986C45CB-9F98-4FBA-95D4-669FBCC50C6D}">
  <ds:schemaRefs>
    <ds:schemaRef ds:uri="http://schemas.microsoft.com/sharepoint/v3/contenttype/forms"/>
  </ds:schemaRefs>
</ds:datastoreItem>
</file>

<file path=customXml/itemProps2.xml><?xml version="1.0" encoding="utf-8"?>
<ds:datastoreItem xmlns:ds="http://schemas.openxmlformats.org/officeDocument/2006/customXml" ds:itemID="{34E92243-6744-4250-8C81-06A634B89881}">
  <ds:schemaRefs>
    <ds:schemaRef ds:uri="746cde4b-492d-48ba-92d7-9676a22a1012"/>
    <ds:schemaRef ds:uri="974c5d5a-69c4-47c0-8134-bb286fa4472c"/>
    <ds:schemaRef ds:uri="http://purl.org/dc/elements/1.1/"/>
    <ds:schemaRef ds:uri="http://purl.org/dc/terms/"/>
    <ds:schemaRef ds:uri="http://schemas.microsoft.com/internal/obd"/>
    <ds:schemaRef ds:uri="http://schemas.microsoft.com/office/2006/documentManagement/types"/>
    <ds:schemaRef ds:uri="http://schemas.microsoft.com/office/2006/metadata/contentType"/>
    <ds:schemaRef ds:uri="http://schemas.microsoft.com/office/2006/metadata/properties"/>
    <ds:schemaRef ds:uri="http://schemas.microsoft.com/office/2006/metadata/properties/metaAttributes"/>
    <ds:schemaRef ds:uri="http://schemas.microsoft.com/office/infopath/2007/PartnerControls"/>
    <ds:schemaRef ds:uri="http://schemas.openxmlformats.org/package/2006/metadata/core-properties"/>
    <ds:schemaRef ds:uri="http://www.w3.org/2001/XMLSchema"/>
  </ds:schemaRefs>
</ds:datastoreItem>
</file>

<file path=customXml/itemProps3.xml><?xml version="1.0" encoding="utf-8"?>
<ds:datastoreItem xmlns:ds="http://schemas.openxmlformats.org/officeDocument/2006/customXml" ds:itemID="{5313B5D3-9FE6-4906-868D-5CC357E257CA}">
  <ds:schemaRefs>
    <ds:schemaRef ds:uri="http://purl.org/dc/terms/"/>
    <ds:schemaRef ds:uri="http://schemas.microsoft.com/office/2006/metadata/properties"/>
    <ds:schemaRef ds:uri="974c5d5a-69c4-47c0-8134-bb286fa4472c"/>
    <ds:schemaRef ds:uri="http://schemas.microsoft.com/office/infopath/2007/PartnerControls"/>
    <ds:schemaRef ds:uri="http://schemas.openxmlformats.org/package/2006/metadata/core-properties"/>
    <ds:schemaRef ds:uri="http://schemas.microsoft.com/office/2006/documentManagement/types"/>
    <ds:schemaRef ds:uri="http://purl.org/dc/dcmitype/"/>
    <ds:schemaRef ds:uri="746cde4b-492d-48ba-92d7-9676a22a1012"/>
    <ds:schemaRef ds:uri="http://www.w3.org/XML/1998/namespace"/>
    <ds:schemaRef ds:uri="http://purl.org/dc/elements/1.1/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773</TotalTime>
  <Words>105</Words>
  <Application>Microsoft Office PowerPoint</Application>
  <PresentationFormat>Custom</PresentationFormat>
  <Paragraphs>2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2013 - 2022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igures!</dc:title>
  <dc:creator>BeKa Leuschen</dc:creator>
  <cp:lastModifiedBy>BeKa Leuschen-Kohl</cp:lastModifiedBy>
  <cp:revision>3</cp:revision>
  <dcterms:created xsi:type="dcterms:W3CDTF">2022-01-14T17:50:55Z</dcterms:created>
  <dcterms:modified xsi:type="dcterms:W3CDTF">2024-11-05T00:55:48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E56102D0D35E964BBFE2C79D04696EE4</vt:lpwstr>
  </property>
  <property fmtid="{D5CDD505-2E9C-101B-9397-08002B2CF9AE}" pid="3" name="MediaServiceImageTags">
    <vt:lpwstr/>
  </property>
  <property fmtid="{D5CDD505-2E9C-101B-9397-08002B2CF9AE}" pid="4" name="MSIP_Label_4044bd30-2ed7-4c9d-9d12-46200872a97b_Enabled">
    <vt:lpwstr>true</vt:lpwstr>
  </property>
  <property fmtid="{D5CDD505-2E9C-101B-9397-08002B2CF9AE}" pid="5" name="MSIP_Label_4044bd30-2ed7-4c9d-9d12-46200872a97b_SetDate">
    <vt:lpwstr>2022-12-15T15:50:22Z</vt:lpwstr>
  </property>
  <property fmtid="{D5CDD505-2E9C-101B-9397-08002B2CF9AE}" pid="6" name="MSIP_Label_4044bd30-2ed7-4c9d-9d12-46200872a97b_Method">
    <vt:lpwstr>Standard</vt:lpwstr>
  </property>
  <property fmtid="{D5CDD505-2E9C-101B-9397-08002B2CF9AE}" pid="7" name="MSIP_Label_4044bd30-2ed7-4c9d-9d12-46200872a97b_Name">
    <vt:lpwstr>defa4170-0d19-0005-0004-bc88714345d2</vt:lpwstr>
  </property>
  <property fmtid="{D5CDD505-2E9C-101B-9397-08002B2CF9AE}" pid="8" name="MSIP_Label_4044bd30-2ed7-4c9d-9d12-46200872a97b_SiteId">
    <vt:lpwstr>4130bd39-7c53-419c-b1e5-8758d6d63f21</vt:lpwstr>
  </property>
  <property fmtid="{D5CDD505-2E9C-101B-9397-08002B2CF9AE}" pid="9" name="MSIP_Label_4044bd30-2ed7-4c9d-9d12-46200872a97b_ActionId">
    <vt:lpwstr>f1376b59-ccc7-4a7c-91ca-02a5a8238883</vt:lpwstr>
  </property>
  <property fmtid="{D5CDD505-2E9C-101B-9397-08002B2CF9AE}" pid="10" name="MSIP_Label_4044bd30-2ed7-4c9d-9d12-46200872a97b_ContentBits">
    <vt:lpwstr>0</vt:lpwstr>
  </property>
</Properties>
</file>